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56" r:id="rId3"/>
    <p:sldId id="257" r:id="rId4"/>
    <p:sldId id="269" r:id="rId5"/>
    <p:sldId id="258" r:id="rId6"/>
    <p:sldId id="268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8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840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0893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651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6381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086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6304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815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52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550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291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412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8C705-D487-4682-9B3B-6143C63410E2}" type="datetimeFigureOut">
              <a:rPr lang="en-GB" smtClean="0"/>
              <a:t>15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3EC7D-A8F9-46B1-A1E2-EFA7A46A51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9695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369" y="2488130"/>
            <a:ext cx="5915025" cy="822313"/>
          </a:xfrm>
        </p:spPr>
        <p:txBody>
          <a:bodyPr>
            <a:normAutofit/>
          </a:bodyPr>
          <a:lstStyle/>
          <a:p>
            <a:r>
              <a:rPr lang="en-GB" sz="1400" b="1" dirty="0"/>
              <a:t>Supplementary table 2. Chi-squared analysis of </a:t>
            </a:r>
            <a:r>
              <a:rPr lang="en-GB" sz="1400" b="1" dirty="0" err="1"/>
              <a:t>clinicopathological</a:t>
            </a:r>
            <a:r>
              <a:rPr lang="en-GB" sz="1400" b="1" dirty="0"/>
              <a:t> parameters in dataset GSE39582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523645" y="3310443"/>
          <a:ext cx="5280475" cy="6284904"/>
        </p:xfrm>
        <a:graphic>
          <a:graphicData uri="http://schemas.openxmlformats.org/drawingml/2006/table">
            <a:tbl>
              <a:tblPr/>
              <a:tblGrid>
                <a:gridCol w="16271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510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660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609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8014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80799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nicopathologica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rameter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RB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ow (n=223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RB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High (n=296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2189"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der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 (5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 (5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47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 (42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 (47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2189"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 70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4 (6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4 (6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29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70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  (3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 (3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2189">
                <a:tc rowSpan="5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M staging 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&lt;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04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 (4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 (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 (4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 (4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 (3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 (3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 (4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2189"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R status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MR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(5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 (2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MMR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 (9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5 (7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(5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 (1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2189"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F status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0 (8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8 (8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T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14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 (16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6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2189"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AS status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 (57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 (6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56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T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 (3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 (37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 (6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2189"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N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itiv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 (6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1 (6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7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 (12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 (24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 (22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 (15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72189"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MP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itiv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 (2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4 (7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 (6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1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 (10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72189">
                <a:tc rowSpan="5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S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S1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(5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 (2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t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S2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 (4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 (24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S3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1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 (1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S4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(1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 (22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07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MS-UNK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 (15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 (1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72189">
                <a:tc rowSpan="6">
                  <a:txBody>
                    <a:bodyPr/>
                    <a:lstStyle/>
                    <a:p>
                      <a:pPr algn="ctr" fontAlgn="t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</a:t>
                      </a:r>
                    </a:p>
                  </a:txBody>
                  <a:tcPr marL="8609" marR="8609" marT="8609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-A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 (25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 (3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6">
                  <a:txBody>
                    <a:bodyPr/>
                    <a:lstStyle/>
                    <a:p>
                      <a:pPr algn="ctr" fontAlgn="t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8</a:t>
                      </a:r>
                    </a:p>
                  </a:txBody>
                  <a:tcPr marL="8609" marR="8609" marT="860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-B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 (17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-C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 (2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 (1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-D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 (16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 (11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-E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 (16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 (13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7218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-UNK</a:t>
                      </a:r>
                    </a:p>
                  </a:txBody>
                  <a:tcPr marL="8609" marR="8609" marT="860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8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 (9%)</a:t>
                      </a:r>
                    </a:p>
                  </a:txBody>
                  <a:tcPr marL="8609" marR="8609" marT="860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</a:tbl>
          </a:graphicData>
        </a:graphic>
      </p:graphicFrame>
      <p:sp>
        <p:nvSpPr>
          <p:cNvPr id="5" name="Title 1"/>
          <p:cNvSpPr txBox="1">
            <a:spLocks/>
          </p:cNvSpPr>
          <p:nvPr/>
        </p:nvSpPr>
        <p:spPr>
          <a:xfrm>
            <a:off x="206369" y="350702"/>
            <a:ext cx="5915025" cy="506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400" b="1" dirty="0"/>
              <a:t>Supplementary table 1: Optimised IHC antibody protocols</a:t>
            </a:r>
            <a:br>
              <a:rPr lang="en-GB" sz="1400" b="1" dirty="0"/>
            </a:br>
            <a:endParaRPr lang="en-GB" sz="1400" b="1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255031" y="1014991"/>
          <a:ext cx="6347938" cy="1012607"/>
        </p:xfrm>
        <a:graphic>
          <a:graphicData uri="http://schemas.openxmlformats.org/drawingml/2006/table">
            <a:tbl>
              <a:tblPr/>
              <a:tblGrid>
                <a:gridCol w="4190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308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40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5401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002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2226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5401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3337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43981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9826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121693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iomarker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tibody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e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ource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munostainer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tigen Retrieva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ilution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cubation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etection Chemistry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s Contro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54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D3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NFIRM anti-CD3 (790-4341)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GV6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entana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nchmark X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C1 for 32 minute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ea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 minutes at 37oC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ptiview DAB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nsi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54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D4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NFIRM anti-CD4 (790-4423)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35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entana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nchmark X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C1 for 60 minute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ea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 minutes at 37oC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ltraview DAB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nsi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063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D8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ti-CD8 (M7103)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D/144B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ako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eica Bond RX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R2 for 20 minute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:50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 minutes at rtp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nd Polymer Refine Detection and Enhancer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nsi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063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XP3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ti-FOXP3 (LS-C210349)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97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SBio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nchmark X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C1 for 48 minute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:50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0 minutes at rtp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ptiview DAB and Amplifier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nsi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54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O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ti-ICOS (#89601)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1K2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ll Signalling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eica Bond RX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R2 for 20 minute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:400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 minutes at rtp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nd Polymer Refine Detection and Enhancer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nsi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6162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D-L1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ENTANA PD-L1 (790-4905)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263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entana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nchmark X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C1 for 64 minutes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eat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 minutes at rtp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ptiview DAB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nsil</a:t>
                      </a:r>
                    </a:p>
                  </a:txBody>
                  <a:tcPr marL="5532" marR="5532" marT="553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272176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611" y="4455273"/>
            <a:ext cx="5975279" cy="197100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658" y="1869837"/>
            <a:ext cx="5948232" cy="192185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02673" y="467591"/>
            <a:ext cx="5694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Supplementary figure 1.  </a:t>
            </a:r>
            <a:r>
              <a:rPr lang="en-GB" sz="1400" dirty="0"/>
              <a:t>CD8 and CD3 IHC expression grouped by </a:t>
            </a:r>
            <a:r>
              <a:rPr lang="en-GB" sz="1400" i="1" dirty="0"/>
              <a:t>IL2RB </a:t>
            </a:r>
            <a:r>
              <a:rPr lang="en-GB" sz="1400" dirty="0"/>
              <a:t>gene expression (median split) in invasive front (IF), tumour body (TB) and stromal regions (SR</a:t>
            </a:r>
            <a:r>
              <a:rPr lang="en-GB" sz="1400"/>
              <a:t>) for </a:t>
            </a:r>
            <a:r>
              <a:rPr lang="en-GB" sz="1400" dirty="0"/>
              <a:t>stage II/III CRC taxonomy cohort. Significance determined using Welch’s T-Test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737509" y="1953729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P=0.25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605904" y="1957097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P=0.07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474299" y="1953729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P=0.0169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03232" y="4556802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P=0.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05904" y="4556801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P=0.168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07160" y="4556800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P=0.217</a:t>
            </a:r>
          </a:p>
        </p:txBody>
      </p:sp>
    </p:spTree>
    <p:extLst>
      <p:ext uri="{BB962C8B-B14F-4D97-AF65-F5344CB8AC3E}">
        <p14:creationId xmlns:p14="http://schemas.microsoft.com/office/powerpoint/2010/main" val="784336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538" y="2206812"/>
            <a:ext cx="5652673" cy="7699188"/>
          </a:xfrm>
        </p:spPr>
      </p:pic>
      <p:sp>
        <p:nvSpPr>
          <p:cNvPr id="5" name="TextBox 4"/>
          <p:cNvSpPr txBox="1"/>
          <p:nvPr/>
        </p:nvSpPr>
        <p:spPr>
          <a:xfrm>
            <a:off x="278998" y="898498"/>
            <a:ext cx="612975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2. transcriptional expression of </a:t>
            </a:r>
            <a:r>
              <a:rPr lang="en-GB" sz="1400" b="1" i="1" dirty="0"/>
              <a:t>IL2RB</a:t>
            </a:r>
            <a:r>
              <a:rPr lang="en-GB" sz="1400" b="1" dirty="0"/>
              <a:t> is an independent prognostic factor in CRC. </a:t>
            </a:r>
            <a:r>
              <a:rPr lang="en-GB" sz="1400" dirty="0"/>
              <a:t>Forest plots showing (A) multi-univariate and (B) multivariate relapse free survival analysis of </a:t>
            </a:r>
            <a:r>
              <a:rPr lang="en-GB" sz="1400" i="1" dirty="0"/>
              <a:t>IL2RB</a:t>
            </a:r>
            <a:r>
              <a:rPr lang="en-GB" sz="1400" dirty="0"/>
              <a:t> and </a:t>
            </a:r>
            <a:r>
              <a:rPr lang="en-GB" sz="1400" dirty="0" err="1"/>
              <a:t>clinicopathological</a:t>
            </a:r>
            <a:r>
              <a:rPr lang="en-GB" sz="1400" dirty="0"/>
              <a:t> variables in CRC cohort GSE39582 (n=519)</a:t>
            </a:r>
          </a:p>
        </p:txBody>
      </p:sp>
    </p:spTree>
    <p:extLst>
      <p:ext uri="{BB962C8B-B14F-4D97-AF65-F5344CB8AC3E}">
        <p14:creationId xmlns:p14="http://schemas.microsoft.com/office/powerpoint/2010/main" val="2262984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GB" sz="1400" b="1" dirty="0"/>
              <a:t>Supplementary Figure 3. Boxplot showing IL2RB mRNA expression grouped by microsatellite instability status</a:t>
            </a:r>
            <a:r>
              <a:rPr lang="en-GB" sz="1400" dirty="0"/>
              <a:t>. Transcriptional expression of IL2RB grouped by MSI status in COAD TCGA RNA </a:t>
            </a:r>
            <a:r>
              <a:rPr lang="en-GB" sz="1400" dirty="0" err="1"/>
              <a:t>seq</a:t>
            </a:r>
            <a:r>
              <a:rPr lang="en-GB" sz="1400" dirty="0"/>
              <a:t> dataset (n=322). Statistical significance determined using ANOVA </a:t>
            </a:r>
            <a:r>
              <a:rPr lang="en-GB" sz="1400" dirty="0">
                <a:solidFill>
                  <a:srgbClr val="FF0000"/>
                </a:solidFill>
              </a:rPr>
              <a:t>( p &lt; 0.0001) </a:t>
            </a: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7" y="2442107"/>
            <a:ext cx="5915025" cy="3802516"/>
          </a:xfrm>
        </p:spPr>
      </p:pic>
    </p:spTree>
    <p:extLst>
      <p:ext uri="{BB962C8B-B14F-4D97-AF65-F5344CB8AC3E}">
        <p14:creationId xmlns:p14="http://schemas.microsoft.com/office/powerpoint/2010/main" val="4263645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11386" t="16948" r="64955" b="5623"/>
          <a:stretch/>
        </p:blipFill>
        <p:spPr>
          <a:xfrm>
            <a:off x="900870" y="4682232"/>
            <a:ext cx="2031612" cy="193457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04289" y="6616811"/>
            <a:ext cx="181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ancreatic Cancer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12986" t="11817" r="61971" b="7674"/>
          <a:stretch/>
        </p:blipFill>
        <p:spPr>
          <a:xfrm>
            <a:off x="3832528" y="4682232"/>
            <a:ext cx="1971779" cy="198090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40763" y="6616811"/>
            <a:ext cx="181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Lung Cancer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/>
          <a:srcRect l="11014" t="5509" r="61507" b="5076"/>
          <a:stretch/>
        </p:blipFill>
        <p:spPr>
          <a:xfrm>
            <a:off x="888994" y="2172049"/>
            <a:ext cx="2043488" cy="188549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238653" y="4028545"/>
            <a:ext cx="1932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olorectal Cancer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/>
          <a:srcRect l="14377" t="13302" r="62203" b="8415"/>
          <a:stretch/>
        </p:blipFill>
        <p:spPr>
          <a:xfrm>
            <a:off x="888994" y="7370188"/>
            <a:ext cx="2043488" cy="188536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004289" y="9255554"/>
            <a:ext cx="181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Breast Cancer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/>
          <a:srcRect l="11594" t="9960" r="61159" b="7674"/>
          <a:stretch/>
        </p:blipFill>
        <p:spPr>
          <a:xfrm>
            <a:off x="3832528" y="2172049"/>
            <a:ext cx="1963544" cy="1854921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441602" y="4003807"/>
            <a:ext cx="1470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Melanoma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7"/>
          <a:srcRect l="12058" t="13671" r="63362" b="6931"/>
          <a:stretch/>
        </p:blipFill>
        <p:spPr>
          <a:xfrm>
            <a:off x="3824575" y="7370187"/>
            <a:ext cx="1979732" cy="1885367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983175" y="9255554"/>
            <a:ext cx="181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Urothelial Cancer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97603" y="416571"/>
            <a:ext cx="635725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4. IL2RB IHC stains small sub populations of immune cells in a subset of patients across a variety of tumour types. </a:t>
            </a:r>
            <a:r>
              <a:rPr lang="en-GB" sz="1400" dirty="0"/>
              <a:t>IL2RB IHC images in CRC, melanoma, pancreatic cancer, lung cancer, breast cancer and urothelial cancer taken from  https://www.proteinatlas.org/</a:t>
            </a:r>
          </a:p>
        </p:txBody>
      </p:sp>
    </p:spTree>
    <p:extLst>
      <p:ext uri="{BB962C8B-B14F-4D97-AF65-F5344CB8AC3E}">
        <p14:creationId xmlns:p14="http://schemas.microsoft.com/office/powerpoint/2010/main" val="16916192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361376"/>
            <a:ext cx="5459937" cy="7436674"/>
          </a:xfrm>
        </p:spPr>
      </p:pic>
      <p:sp>
        <p:nvSpPr>
          <p:cNvPr id="6" name="Rectangle 5"/>
          <p:cNvSpPr/>
          <p:nvPr/>
        </p:nvSpPr>
        <p:spPr>
          <a:xfrm>
            <a:off x="361950" y="127057"/>
            <a:ext cx="6343650" cy="23974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5 – Predictive gene signatures of response to immune checkpoint blockade positively correlate with </a:t>
            </a:r>
            <a:r>
              <a:rPr lang="en-GB" sz="1400" b="1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L2RB</a:t>
            </a:r>
            <a:r>
              <a:rPr lang="en-GB" sz="1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expression in CRC microarray and RNA-</a:t>
            </a:r>
            <a:r>
              <a:rPr lang="en-GB" sz="1400" b="1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q</a:t>
            </a:r>
            <a:r>
              <a:rPr lang="en-GB" sz="1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CGA data sets. 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+B) Percentile rank mRNA expression of </a:t>
            </a:r>
            <a:r>
              <a:rPr lang="en-GB" sz="14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L2RB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or microarray and RNA-</a:t>
            </a:r>
            <a:r>
              <a:rPr lang="en-GB" sz="14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q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ata plotted versus percentile rank for </a:t>
            </a:r>
            <a:r>
              <a:rPr lang="en-GB" sz="14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urvalumab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predictive gene signature. (C+D) Percentile rank mRNA expression of </a:t>
            </a:r>
            <a:r>
              <a:rPr lang="en-GB" sz="14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L2RB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or microarray and RNA-</a:t>
            </a:r>
            <a:r>
              <a:rPr lang="en-GB" sz="14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q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ata plotted versus percentile rank of NK cell/anti-pd1 gene signature. (E+F) Percentile rank mRNA expression of </a:t>
            </a:r>
            <a:r>
              <a:rPr lang="en-GB" sz="14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L2RB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or microarray and RNA-</a:t>
            </a:r>
            <a:r>
              <a:rPr lang="en-GB" sz="14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q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ata plotted versus percentile rank of </a:t>
            </a:r>
            <a:r>
              <a:rPr lang="en-GB" sz="14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embrolizumab</a:t>
            </a:r>
            <a:r>
              <a:rPr lang="en-GB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gene signature. Correlation was determined using Pearson correlations coefficient and p value using a paired two-sided t-test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7887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83</Words>
  <Application>Microsoft Office PowerPoint</Application>
  <PresentationFormat>A4 Paper (210x297 mm)</PresentationFormat>
  <Paragraphs>2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ry table 2. Chi-squared analysis of clinicopathological parameters in dataset GSE39582</vt:lpstr>
      <vt:lpstr>PowerPoint Presentation</vt:lpstr>
      <vt:lpstr>PowerPoint Presentation</vt:lpstr>
      <vt:lpstr>Supplementary Figure 3. Boxplot showing IL2RB mRNA expression grouped by microsatellite instability status. Transcriptional expression of IL2RB grouped by MSI status in COAD TCGA RNA seq dataset (n=322). Statistical significance determined using ANOVA ( p &lt; 0.0001) </vt:lpstr>
      <vt:lpstr>PowerPoint Presentation</vt:lpstr>
      <vt:lpstr>PowerPoint Presentation</vt:lpstr>
    </vt:vector>
  </TitlesOfParts>
  <Company>Medicine, Dentistry and Biomedical 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Alderdice</dc:creator>
  <cp:lastModifiedBy>Matt Alderdice</cp:lastModifiedBy>
  <cp:revision>21</cp:revision>
  <dcterms:created xsi:type="dcterms:W3CDTF">2019-02-27T10:59:41Z</dcterms:created>
  <dcterms:modified xsi:type="dcterms:W3CDTF">2021-02-15T08:52:17Z</dcterms:modified>
</cp:coreProperties>
</file>